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7" r:id="rId2"/>
    <p:sldId id="27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FC7BE5E-1E49-46CB-923B-7A6E2AE4093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61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547664" y="1853208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mature</a:t>
            </a:r>
          </a:p>
        </p:txBody>
      </p:sp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1628800"/>
            <a:ext cx="3240360" cy="5387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835696" y="3789040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7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35696" y="2473151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aspase-3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13967" y="3049215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Cleaved Caspase-3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547664" y="1700808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precursor</a:t>
            </a:r>
          </a:p>
        </p:txBody>
      </p:sp>
      <p:cxnSp>
        <p:nvCxnSpPr>
          <p:cNvPr id="23" name="직선 화살표 연결선 22"/>
          <p:cNvCxnSpPr/>
          <p:nvPr/>
        </p:nvCxnSpPr>
        <p:spPr>
          <a:xfrm>
            <a:off x="2490809" y="2007097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043608" y="177281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DR5</a:t>
            </a:r>
          </a:p>
        </p:txBody>
      </p:sp>
      <p:sp>
        <p:nvSpPr>
          <p:cNvPr id="26" name="직사각형 25"/>
          <p:cNvSpPr/>
          <p:nvPr/>
        </p:nvSpPr>
        <p:spPr>
          <a:xfrm>
            <a:off x="-4936" y="0"/>
            <a:ext cx="898765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8 Effect of PF and TRAIL co-treatment combined with DR5 siRNA on apoptosis</a:t>
            </a:r>
            <a:endParaRPr lang="en-US" altLang="ko-KR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76905" y="1052736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887817" y="899428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LPS 224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051720" y="5354632"/>
            <a:ext cx="424847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TRAIL       -      +        -      +      -       +       -       + </a:t>
            </a:r>
          </a:p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F              -       -        +     +      -        -       +       + </a:t>
            </a:r>
          </a:p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DR5</a:t>
            </a:r>
            <a:r>
              <a:rPr lang="en-US" altLang="ko-KR" sz="1400" b="1" i="1" dirty="0" smtClean="0">
                <a:latin typeface="Times New Roman" pitchFamily="18" charset="0"/>
                <a:cs typeface="Times New Roman" pitchFamily="18" charset="0"/>
              </a:rPr>
              <a:t>i        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 -       -        -      -      +       +       +       +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012160" y="177281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0kD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012160" y="249289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5kD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012160" y="313116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8kDa 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005119" y="364895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37kDa</a:t>
            </a:r>
          </a:p>
        </p:txBody>
      </p:sp>
      <p:cxnSp>
        <p:nvCxnSpPr>
          <p:cNvPr id="38" name="직선 화살표 연결선 37"/>
          <p:cNvCxnSpPr/>
          <p:nvPr/>
        </p:nvCxnSpPr>
        <p:spPr>
          <a:xfrm>
            <a:off x="2509646" y="184482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화살표 연결선 38"/>
          <p:cNvCxnSpPr/>
          <p:nvPr/>
        </p:nvCxnSpPr>
        <p:spPr>
          <a:xfrm>
            <a:off x="5803177" y="1916832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792" y="2906563"/>
            <a:ext cx="3240360" cy="522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0" name="직선 화살표 연결선 39"/>
          <p:cNvCxnSpPr/>
          <p:nvPr/>
        </p:nvCxnSpPr>
        <p:spPr>
          <a:xfrm>
            <a:off x="5796136" y="328498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8628" y="2310136"/>
            <a:ext cx="3221523" cy="490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8002" y="3562945"/>
            <a:ext cx="3212149" cy="12963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"/>
          <p:cNvSpPr txBox="1"/>
          <p:nvPr/>
        </p:nvSpPr>
        <p:spPr>
          <a:xfrm>
            <a:off x="6012160" y="4365104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20kDa</a:t>
            </a:r>
          </a:p>
        </p:txBody>
      </p:sp>
      <p:cxnSp>
        <p:nvCxnSpPr>
          <p:cNvPr id="44" name="직선 화살표 연결선 43"/>
          <p:cNvCxnSpPr/>
          <p:nvPr/>
        </p:nvCxnSpPr>
        <p:spPr>
          <a:xfrm>
            <a:off x="5796136" y="3789040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화살표 연결선 44"/>
          <p:cNvCxnSpPr/>
          <p:nvPr/>
        </p:nvCxnSpPr>
        <p:spPr>
          <a:xfrm>
            <a:off x="5796136" y="4528865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8628" y="4903782"/>
            <a:ext cx="3221524" cy="450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2051720" y="4921423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012160" y="499343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</p:spTree>
    <p:extLst>
      <p:ext uri="{BB962C8B-B14F-4D97-AF65-F5344CB8AC3E}">
        <p14:creationId xmlns:p14="http://schemas.microsoft.com/office/powerpoint/2010/main" val="2907683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0607" y="1988840"/>
            <a:ext cx="3743601" cy="1423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986320" y="1277196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-3425" y="-15231"/>
            <a:ext cx="254108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8</a:t>
            </a:r>
            <a:endParaRPr lang="ko-KR" altLang="en-US" sz="2000" dirty="0"/>
          </a:p>
        </p:txBody>
      </p:sp>
      <p:sp>
        <p:nvSpPr>
          <p:cNvPr id="12" name="TextBox 11"/>
          <p:cNvSpPr txBox="1"/>
          <p:nvPr/>
        </p:nvSpPr>
        <p:spPr>
          <a:xfrm>
            <a:off x="1465663" y="2064730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Arial" pitchFamily="34" charset="0"/>
                <a:cs typeface="Arial" pitchFamily="34" charset="0"/>
              </a:rPr>
              <a:t>Caspase-8</a:t>
            </a:r>
            <a:endParaRPr lang="hsb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031833" y="1244660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LPS 224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63688" y="3933056"/>
            <a:ext cx="55446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TRAIL             -        +        -        +       -         +        -        + </a:t>
            </a:r>
          </a:p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F                    -         -        +        +       -         -        +        + </a:t>
            </a:r>
          </a:p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DR5</a:t>
            </a:r>
            <a:r>
              <a:rPr lang="en-US" altLang="ko-KR" sz="1400" b="1" i="1" dirty="0" smtClean="0">
                <a:latin typeface="Times New Roman" pitchFamily="18" charset="0"/>
                <a:cs typeface="Times New Roman" pitchFamily="18" charset="0"/>
              </a:rPr>
              <a:t>i              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 -         -         -         -      +         +       +        +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588224" y="2033875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2kD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600849" y="224989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3kD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596850" y="2485668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1kD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601477" y="294519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18kDa</a:t>
            </a:r>
          </a:p>
        </p:txBody>
      </p:sp>
      <p:pic>
        <p:nvPicPr>
          <p:cNvPr id="25" name="Picture 1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0606" y="3501008"/>
            <a:ext cx="3743601" cy="411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1907704" y="3501008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604750" y="3552700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  <p:cxnSp>
        <p:nvCxnSpPr>
          <p:cNvPr id="33" name="직선 화살표 연결선 32"/>
          <p:cNvCxnSpPr/>
          <p:nvPr/>
        </p:nvCxnSpPr>
        <p:spPr>
          <a:xfrm>
            <a:off x="6372200" y="220486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/>
          <p:cNvCxnSpPr/>
          <p:nvPr/>
        </p:nvCxnSpPr>
        <p:spPr>
          <a:xfrm>
            <a:off x="6372200" y="235726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화살표 연결선 34"/>
          <p:cNvCxnSpPr/>
          <p:nvPr/>
        </p:nvCxnSpPr>
        <p:spPr>
          <a:xfrm>
            <a:off x="6372200" y="2636912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0606" y="2895243"/>
            <a:ext cx="3743601" cy="588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6" name="직선 화살표 연결선 35"/>
          <p:cNvCxnSpPr/>
          <p:nvPr/>
        </p:nvCxnSpPr>
        <p:spPr>
          <a:xfrm>
            <a:off x="6346322" y="3094838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6848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1</TotalTime>
  <Words>102</Words>
  <Application>Microsoft Office PowerPoint</Application>
  <PresentationFormat>화면 슬라이드 쇼(4:3)</PresentationFormat>
  <Paragraphs>33</Paragraphs>
  <Slides>2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33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